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1" autoAdjust="0"/>
    <p:restoredTop sz="94660"/>
  </p:normalViewPr>
  <p:slideViewPr>
    <p:cSldViewPr snapToGrid="0">
      <p:cViewPr varScale="1">
        <p:scale>
          <a:sx n="56" d="100"/>
          <a:sy n="56" d="100"/>
        </p:scale>
        <p:origin x="125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17588B-19F5-4DD8-AD7C-F575FE934FC7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4F7F04-80A5-4E09-A084-77EA641FB6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894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4F7F04-80A5-4E09-A084-77EA641FB6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5173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344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544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069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689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652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49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624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356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3005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02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59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0CCBD-4021-4A43-A714-EB3288C0DBAF}" type="datetimeFigureOut">
              <a:rPr lang="en-US" smtClean="0"/>
              <a:t>5/1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17C41-8571-47B0-8EF5-E53C8F55E8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31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7200" y="228600"/>
            <a:ext cx="1905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4680442"/>
              </p:ext>
            </p:extLst>
          </p:nvPr>
        </p:nvGraphicFramePr>
        <p:xfrm>
          <a:off x="515937" y="2246485"/>
          <a:ext cx="5731757" cy="782272"/>
        </p:xfrm>
        <a:graphic>
          <a:graphicData uri="http://schemas.openxmlformats.org/drawingml/2006/table">
            <a:tbl>
              <a:tblPr/>
              <a:tblGrid>
                <a:gridCol w="423971">
                  <a:extLst>
                    <a:ext uri="{9D8B030D-6E8A-4147-A177-3AD203B41FA5}">
                      <a16:colId xmlns:a16="http://schemas.microsoft.com/office/drawing/2014/main" val="3323460065"/>
                    </a:ext>
                  </a:extLst>
                </a:gridCol>
                <a:gridCol w="454953">
                  <a:extLst>
                    <a:ext uri="{9D8B030D-6E8A-4147-A177-3AD203B41FA5}">
                      <a16:colId xmlns:a16="http://schemas.microsoft.com/office/drawing/2014/main" val="568637722"/>
                    </a:ext>
                  </a:extLst>
                </a:gridCol>
                <a:gridCol w="450062">
                  <a:extLst>
                    <a:ext uri="{9D8B030D-6E8A-4147-A177-3AD203B41FA5}">
                      <a16:colId xmlns:a16="http://schemas.microsoft.com/office/drawing/2014/main" val="3815107099"/>
                    </a:ext>
                  </a:extLst>
                </a:gridCol>
                <a:gridCol w="410925">
                  <a:extLst>
                    <a:ext uri="{9D8B030D-6E8A-4147-A177-3AD203B41FA5}">
                      <a16:colId xmlns:a16="http://schemas.microsoft.com/office/drawing/2014/main" val="1279123619"/>
                    </a:ext>
                  </a:extLst>
                </a:gridCol>
                <a:gridCol w="425602">
                  <a:extLst>
                    <a:ext uri="{9D8B030D-6E8A-4147-A177-3AD203B41FA5}">
                      <a16:colId xmlns:a16="http://schemas.microsoft.com/office/drawing/2014/main" val="602527196"/>
                    </a:ext>
                  </a:extLst>
                </a:gridCol>
                <a:gridCol w="464737">
                  <a:extLst>
                    <a:ext uri="{9D8B030D-6E8A-4147-A177-3AD203B41FA5}">
                      <a16:colId xmlns:a16="http://schemas.microsoft.com/office/drawing/2014/main" val="3481504924"/>
                    </a:ext>
                  </a:extLst>
                </a:gridCol>
                <a:gridCol w="435385">
                  <a:extLst>
                    <a:ext uri="{9D8B030D-6E8A-4147-A177-3AD203B41FA5}">
                      <a16:colId xmlns:a16="http://schemas.microsoft.com/office/drawing/2014/main" val="3534141424"/>
                    </a:ext>
                  </a:extLst>
                </a:gridCol>
                <a:gridCol w="440277">
                  <a:extLst>
                    <a:ext uri="{9D8B030D-6E8A-4147-A177-3AD203B41FA5}">
                      <a16:colId xmlns:a16="http://schemas.microsoft.com/office/drawing/2014/main" val="2778719102"/>
                    </a:ext>
                  </a:extLst>
                </a:gridCol>
                <a:gridCol w="396249">
                  <a:extLst>
                    <a:ext uri="{9D8B030D-6E8A-4147-A177-3AD203B41FA5}">
                      <a16:colId xmlns:a16="http://schemas.microsoft.com/office/drawing/2014/main" val="1917917426"/>
                    </a:ext>
                  </a:extLst>
                </a:gridCol>
                <a:gridCol w="469629">
                  <a:extLst>
                    <a:ext uri="{9D8B030D-6E8A-4147-A177-3AD203B41FA5}">
                      <a16:colId xmlns:a16="http://schemas.microsoft.com/office/drawing/2014/main" val="2150699535"/>
                    </a:ext>
                  </a:extLst>
                </a:gridCol>
                <a:gridCol w="489197">
                  <a:extLst>
                    <a:ext uri="{9D8B030D-6E8A-4147-A177-3AD203B41FA5}">
                      <a16:colId xmlns:a16="http://schemas.microsoft.com/office/drawing/2014/main" val="1200257444"/>
                    </a:ext>
                  </a:extLst>
                </a:gridCol>
                <a:gridCol w="430493">
                  <a:extLst>
                    <a:ext uri="{9D8B030D-6E8A-4147-A177-3AD203B41FA5}">
                      <a16:colId xmlns:a16="http://schemas.microsoft.com/office/drawing/2014/main" val="1392914563"/>
                    </a:ext>
                  </a:extLst>
                </a:gridCol>
                <a:gridCol w="440277">
                  <a:extLst>
                    <a:ext uri="{9D8B030D-6E8A-4147-A177-3AD203B41FA5}">
                      <a16:colId xmlns:a16="http://schemas.microsoft.com/office/drawing/2014/main" val="848810403"/>
                    </a:ext>
                  </a:extLst>
                </a:gridCol>
              </a:tblGrid>
              <a:tr h="97784">
                <a:tc>
                  <a:txBody>
                    <a:bodyPr/>
                    <a:lstStyle/>
                    <a:p>
                      <a:pPr algn="ctr" fontAlgn="b"/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041" marR="5041" marT="5041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e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dul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mbryos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101711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lemen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ificanc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ificanc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adequat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 deficient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gnificance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AAA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3060920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inc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81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.14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.56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.1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3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**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6324968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lcium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756.0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405.0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61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42.0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946.0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7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3.1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8.9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097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58968373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pper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.49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444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 detected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t detected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84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8783654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ron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6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63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38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28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9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35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8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428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3607968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gnesium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87.9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1.9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0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9.7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7.20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29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.76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.1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5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408502"/>
                  </a:ext>
                </a:extLst>
              </a:tr>
              <a:tr h="97784"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lenium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98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46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14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86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45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2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3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759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5041" marR="5041" marT="504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467102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54881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17</TotalTime>
  <Words>109</Words>
  <Application>Microsoft Office PowerPoint</Application>
  <PresentationFormat>On-screen Show (4:3)</PresentationFormat>
  <Paragraphs>9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aver, Laura</dc:creator>
  <cp:lastModifiedBy>Beaver, Laura</cp:lastModifiedBy>
  <cp:revision>114</cp:revision>
  <cp:lastPrinted>2017-01-10T20:43:22Z</cp:lastPrinted>
  <dcterms:created xsi:type="dcterms:W3CDTF">2016-12-13T00:19:40Z</dcterms:created>
  <dcterms:modified xsi:type="dcterms:W3CDTF">2017-05-10T19:57:35Z</dcterms:modified>
</cp:coreProperties>
</file>